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4" d="100"/>
          <a:sy n="94" d="100"/>
        </p:scale>
        <p:origin x="-1284" y="17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98D66-2977-4A2E-A65F-615533E28FA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5CF4F-6224-494C-9B80-B110B0ED3E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7217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98D66-2977-4A2E-A65F-615533E28FA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5CF4F-6224-494C-9B80-B110B0ED3E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922649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98D66-2977-4A2E-A65F-615533E28FA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5CF4F-6224-494C-9B80-B110B0ED3E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34353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98D66-2977-4A2E-A65F-615533E28FA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5CF4F-6224-494C-9B80-B110B0ED3E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26876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98D66-2977-4A2E-A65F-615533E28FA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5CF4F-6224-494C-9B80-B110B0ED3E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32629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98D66-2977-4A2E-A65F-615533E28FA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5CF4F-6224-494C-9B80-B110B0ED3E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313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98D66-2977-4A2E-A65F-615533E28FA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5CF4F-6224-494C-9B80-B110B0ED3E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60306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98D66-2977-4A2E-A65F-615533E28FA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5CF4F-6224-494C-9B80-B110B0ED3E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31929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98D66-2977-4A2E-A65F-615533E28FA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5CF4F-6224-494C-9B80-B110B0ED3E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58849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98D66-2977-4A2E-A65F-615533E28FA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5CF4F-6224-494C-9B80-B110B0ED3E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0836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98D66-2977-4A2E-A65F-615533E28FA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5CF4F-6224-494C-9B80-B110B0ED3E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39018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298D66-2977-4A2E-A65F-615533E28FA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45CF4F-6224-494C-9B80-B110B0ED3E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2065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179512" y="6387452"/>
            <a:ext cx="196925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A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de-D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5576" y="372800"/>
            <a:ext cx="7776864" cy="56567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30504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186291" y="6400737"/>
            <a:ext cx="196124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B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de-D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7584" y="1411936"/>
            <a:ext cx="7432494" cy="37146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02940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179512" y="6406071"/>
            <a:ext cx="196925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C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de-D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2760" y="260648"/>
            <a:ext cx="6740325" cy="61268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9021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251520" y="6525951"/>
            <a:ext cx="196925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D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de-D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2016" y="1340768"/>
            <a:ext cx="7491986" cy="37444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738529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</Words>
  <Application>Microsoft Office PowerPoint</Application>
  <PresentationFormat>Презентация на цял екран (4:3)</PresentationFormat>
  <Paragraphs>4</Paragraphs>
  <Slides>4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лавия на слайдовете</vt:lpstr>
      </vt:variant>
      <vt:variant>
        <vt:i4>4</vt:i4>
      </vt:variant>
    </vt:vector>
  </HeadingPairs>
  <TitlesOfParts>
    <vt:vector size="5" baseType="lpstr">
      <vt:lpstr>Larissa</vt:lpstr>
      <vt:lpstr>Презентация на PowerPoint</vt:lpstr>
      <vt:lpstr>Презентация на PowerPoint</vt:lpstr>
      <vt:lpstr>Презентация на PowerPoint</vt:lpstr>
      <vt:lpstr>Презентация на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tandart</dc:creator>
  <cp:lastModifiedBy>ACER</cp:lastModifiedBy>
  <cp:revision>11</cp:revision>
  <dcterms:created xsi:type="dcterms:W3CDTF">2019-05-28T09:51:12Z</dcterms:created>
  <dcterms:modified xsi:type="dcterms:W3CDTF">2019-08-30T12:26:48Z</dcterms:modified>
</cp:coreProperties>
</file>